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92" d="100"/>
          <a:sy n="92" d="100"/>
        </p:scale>
        <p:origin x="1877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4" Type="http://schemas.openxmlformats.org/officeDocument/2006/relationships/image" Target="../media/image4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00E8D-228E-4179-81C4-A77CED363A3A}" type="datetimeFigureOut">
              <a:rPr lang="de-DE" smtClean="0"/>
              <a:t>03.10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E5E5DA-62E8-4AB7-AB52-4E430D42D49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022160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00E8D-228E-4179-81C4-A77CED363A3A}" type="datetimeFigureOut">
              <a:rPr lang="de-DE" smtClean="0"/>
              <a:t>03.10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E5E5DA-62E8-4AB7-AB52-4E430D42D49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803869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00E8D-228E-4179-81C4-A77CED363A3A}" type="datetimeFigureOut">
              <a:rPr lang="de-DE" smtClean="0"/>
              <a:t>03.10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E5E5DA-62E8-4AB7-AB52-4E430D42D49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111435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00E8D-228E-4179-81C4-A77CED363A3A}" type="datetimeFigureOut">
              <a:rPr lang="de-DE" smtClean="0"/>
              <a:t>03.10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E5E5DA-62E8-4AB7-AB52-4E430D42D49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31144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00E8D-228E-4179-81C4-A77CED363A3A}" type="datetimeFigureOut">
              <a:rPr lang="de-DE" smtClean="0"/>
              <a:t>03.10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E5E5DA-62E8-4AB7-AB52-4E430D42D49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973919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00E8D-228E-4179-81C4-A77CED363A3A}" type="datetimeFigureOut">
              <a:rPr lang="de-DE" smtClean="0"/>
              <a:t>03.10.2023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E5E5DA-62E8-4AB7-AB52-4E430D42D49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565127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00E8D-228E-4179-81C4-A77CED363A3A}" type="datetimeFigureOut">
              <a:rPr lang="de-DE" smtClean="0"/>
              <a:t>03.10.2023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E5E5DA-62E8-4AB7-AB52-4E430D42D49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405858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00E8D-228E-4179-81C4-A77CED363A3A}" type="datetimeFigureOut">
              <a:rPr lang="de-DE" smtClean="0"/>
              <a:t>03.10.2023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E5E5DA-62E8-4AB7-AB52-4E430D42D49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718468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00E8D-228E-4179-81C4-A77CED363A3A}" type="datetimeFigureOut">
              <a:rPr lang="de-DE" smtClean="0"/>
              <a:t>03.10.2023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E5E5DA-62E8-4AB7-AB52-4E430D42D49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044833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00E8D-228E-4179-81C4-A77CED363A3A}" type="datetimeFigureOut">
              <a:rPr lang="de-DE" smtClean="0"/>
              <a:t>03.10.2023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E5E5DA-62E8-4AB7-AB52-4E430D42D49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878382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00E8D-228E-4179-81C4-A77CED363A3A}" type="datetimeFigureOut">
              <a:rPr lang="de-DE" smtClean="0"/>
              <a:t>03.10.2023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E5E5DA-62E8-4AB7-AB52-4E430D42D49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455851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100E8D-228E-4179-81C4-A77CED363A3A}" type="datetimeFigureOut">
              <a:rPr lang="de-DE" smtClean="0"/>
              <a:t>03.10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E5E5DA-62E8-4AB7-AB52-4E430D42D49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307717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10" Type="http://schemas.openxmlformats.org/officeDocument/2006/relationships/image" Target="../media/image4.emf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pieren 3">
            <a:extLst>
              <a:ext uri="{FF2B5EF4-FFF2-40B4-BE49-F238E27FC236}">
                <a16:creationId xmlns:a16="http://schemas.microsoft.com/office/drawing/2014/main" id="{DF0F9900-72C2-4CE9-83A3-64E57C4AB3CA}"/>
              </a:ext>
            </a:extLst>
          </p:cNvPr>
          <p:cNvGrpSpPr/>
          <p:nvPr/>
        </p:nvGrpSpPr>
        <p:grpSpPr>
          <a:xfrm>
            <a:off x="-681074" y="291420"/>
            <a:ext cx="7668479" cy="9569274"/>
            <a:chOff x="-681074" y="291420"/>
            <a:chExt cx="7668479" cy="9569274"/>
          </a:xfrm>
        </p:grpSpPr>
        <p:grpSp>
          <p:nvGrpSpPr>
            <p:cNvPr id="5" name="Gruppieren 4">
              <a:extLst>
                <a:ext uri="{FF2B5EF4-FFF2-40B4-BE49-F238E27FC236}">
                  <a16:creationId xmlns:a16="http://schemas.microsoft.com/office/drawing/2014/main" id="{06B4123C-F5EC-469C-A03A-28DC4BC08071}"/>
                </a:ext>
              </a:extLst>
            </p:cNvPr>
            <p:cNvGrpSpPr/>
            <p:nvPr/>
          </p:nvGrpSpPr>
          <p:grpSpPr>
            <a:xfrm>
              <a:off x="-681074" y="291420"/>
              <a:ext cx="7349236" cy="9569274"/>
              <a:chOff x="-537381" y="291420"/>
              <a:chExt cx="7349236" cy="9569274"/>
            </a:xfrm>
          </p:grpSpPr>
          <p:grpSp>
            <p:nvGrpSpPr>
              <p:cNvPr id="11" name="Gruppieren 10">
                <a:extLst>
                  <a:ext uri="{FF2B5EF4-FFF2-40B4-BE49-F238E27FC236}">
                    <a16:creationId xmlns:a16="http://schemas.microsoft.com/office/drawing/2014/main" id="{29F00F62-4437-4ED2-88A0-A41BFFA2C2C9}"/>
                  </a:ext>
                </a:extLst>
              </p:cNvPr>
              <p:cNvGrpSpPr/>
              <p:nvPr/>
            </p:nvGrpSpPr>
            <p:grpSpPr>
              <a:xfrm>
                <a:off x="-537381" y="791820"/>
                <a:ext cx="4775707" cy="9068874"/>
                <a:chOff x="0" y="658055"/>
                <a:chExt cx="4090619" cy="7532363"/>
              </a:xfrm>
            </p:grpSpPr>
            <p:sp>
              <p:nvSpPr>
                <p:cNvPr id="18" name="Textfeld 17">
                  <a:extLst>
                    <a:ext uri="{FF2B5EF4-FFF2-40B4-BE49-F238E27FC236}">
                      <a16:creationId xmlns:a16="http://schemas.microsoft.com/office/drawing/2014/main" id="{32AA0EA4-5EA9-45DC-A26E-8784FC1CC630}"/>
                    </a:ext>
                  </a:extLst>
                </p:cNvPr>
                <p:cNvSpPr txBox="1"/>
                <p:nvPr/>
              </p:nvSpPr>
              <p:spPr>
                <a:xfrm>
                  <a:off x="645175" y="666670"/>
                  <a:ext cx="487299" cy="25563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de-DE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</a:t>
                  </a:r>
                </a:p>
              </p:txBody>
            </p:sp>
            <p:sp>
              <p:nvSpPr>
                <p:cNvPr id="19" name="Textfeld 18">
                  <a:extLst>
                    <a:ext uri="{FF2B5EF4-FFF2-40B4-BE49-F238E27FC236}">
                      <a16:creationId xmlns:a16="http://schemas.microsoft.com/office/drawing/2014/main" id="{A4A93D49-B54B-4C9E-82FE-B06C96F56E30}"/>
                    </a:ext>
                  </a:extLst>
                </p:cNvPr>
                <p:cNvSpPr txBox="1"/>
                <p:nvPr/>
              </p:nvSpPr>
              <p:spPr>
                <a:xfrm>
                  <a:off x="3482291" y="658055"/>
                  <a:ext cx="608328" cy="25563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de-DE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</a:t>
                  </a:r>
                </a:p>
              </p:txBody>
            </p:sp>
            <p:sp>
              <p:nvSpPr>
                <p:cNvPr id="20" name="Textfeld 19">
                  <a:extLst>
                    <a:ext uri="{FF2B5EF4-FFF2-40B4-BE49-F238E27FC236}">
                      <a16:creationId xmlns:a16="http://schemas.microsoft.com/office/drawing/2014/main" id="{E19301C7-E354-4663-B373-03FE7251F3A3}"/>
                    </a:ext>
                  </a:extLst>
                </p:cNvPr>
                <p:cNvSpPr txBox="1"/>
                <p:nvPr/>
              </p:nvSpPr>
              <p:spPr>
                <a:xfrm>
                  <a:off x="547140" y="2853849"/>
                  <a:ext cx="608328" cy="25563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de-DE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</a:t>
                  </a:r>
                </a:p>
              </p:txBody>
            </p:sp>
            <p:sp>
              <p:nvSpPr>
                <p:cNvPr id="21" name="Textfeld 20">
                  <a:extLst>
                    <a:ext uri="{FF2B5EF4-FFF2-40B4-BE49-F238E27FC236}">
                      <a16:creationId xmlns:a16="http://schemas.microsoft.com/office/drawing/2014/main" id="{B0D4F816-9D42-4C9D-BD5C-3895B1633AF0}"/>
                    </a:ext>
                  </a:extLst>
                </p:cNvPr>
                <p:cNvSpPr txBox="1"/>
                <p:nvPr/>
              </p:nvSpPr>
              <p:spPr>
                <a:xfrm>
                  <a:off x="3477745" y="2836634"/>
                  <a:ext cx="289970" cy="25563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de-DE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</a:t>
                  </a:r>
                </a:p>
              </p:txBody>
            </p:sp>
            <p:sp>
              <p:nvSpPr>
                <p:cNvPr id="22" name="Textfeld 21">
                  <a:extLst>
                    <a:ext uri="{FF2B5EF4-FFF2-40B4-BE49-F238E27FC236}">
                      <a16:creationId xmlns:a16="http://schemas.microsoft.com/office/drawing/2014/main" id="{78E7EA13-786C-401B-A45F-262C257060E8}"/>
                    </a:ext>
                  </a:extLst>
                </p:cNvPr>
                <p:cNvSpPr txBox="1"/>
                <p:nvPr/>
              </p:nvSpPr>
              <p:spPr>
                <a:xfrm>
                  <a:off x="3429185" y="7492574"/>
                  <a:ext cx="608328" cy="25563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endParaRPr lang="de-DE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3" name="Textfeld 22">
                  <a:extLst>
                    <a:ext uri="{FF2B5EF4-FFF2-40B4-BE49-F238E27FC236}">
                      <a16:creationId xmlns:a16="http://schemas.microsoft.com/office/drawing/2014/main" id="{BDC910B5-230B-4844-BC1F-EA4C806F710E}"/>
                    </a:ext>
                  </a:extLst>
                </p:cNvPr>
                <p:cNvSpPr txBox="1"/>
                <p:nvPr/>
              </p:nvSpPr>
              <p:spPr>
                <a:xfrm>
                  <a:off x="0" y="7513447"/>
                  <a:ext cx="608328" cy="25563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endParaRPr lang="de-DE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4" name="Textfeld 23">
                  <a:extLst>
                    <a:ext uri="{FF2B5EF4-FFF2-40B4-BE49-F238E27FC236}">
                      <a16:creationId xmlns:a16="http://schemas.microsoft.com/office/drawing/2014/main" id="{4FFB43BE-E7D3-41E8-97C3-A87239819476}"/>
                    </a:ext>
                  </a:extLst>
                </p:cNvPr>
                <p:cNvSpPr txBox="1"/>
                <p:nvPr/>
              </p:nvSpPr>
              <p:spPr>
                <a:xfrm>
                  <a:off x="2866228" y="7934787"/>
                  <a:ext cx="542364" cy="25563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endParaRPr lang="de-DE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2" name="Textfeld 11">
                <a:extLst>
                  <a:ext uri="{FF2B5EF4-FFF2-40B4-BE49-F238E27FC236}">
                    <a16:creationId xmlns:a16="http://schemas.microsoft.com/office/drawing/2014/main" id="{37DA643C-13A8-4C1E-99B7-FD53DB30470D}"/>
                  </a:ext>
                </a:extLst>
              </p:cNvPr>
              <p:cNvSpPr txBox="1"/>
              <p:nvPr/>
            </p:nvSpPr>
            <p:spPr>
              <a:xfrm>
                <a:off x="4081579" y="298284"/>
                <a:ext cx="2730276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6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Def</a:t>
                </a:r>
                <a:r>
                  <a:rPr lang="de-DE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. </a:t>
                </a:r>
                <a:r>
                  <a:rPr lang="de-DE" sz="16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radiochemotherapy</a:t>
                </a:r>
                <a:endParaRPr lang="de-DE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" name="Textfeld 12">
                <a:extLst>
                  <a:ext uri="{FF2B5EF4-FFF2-40B4-BE49-F238E27FC236}">
                    <a16:creationId xmlns:a16="http://schemas.microsoft.com/office/drawing/2014/main" id="{52A2F36D-9EBF-4E73-B14D-91144B0D07B3}"/>
                  </a:ext>
                </a:extLst>
              </p:cNvPr>
              <p:cNvSpPr txBox="1"/>
              <p:nvPr/>
            </p:nvSpPr>
            <p:spPr>
              <a:xfrm>
                <a:off x="887691" y="291420"/>
                <a:ext cx="2455543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6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urgery</a:t>
                </a:r>
                <a:r>
                  <a:rPr lang="de-DE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+ </a:t>
                </a:r>
                <a:r>
                  <a:rPr lang="de-DE" sz="16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adj.</a:t>
                </a:r>
                <a:r>
                  <a:rPr lang="de-DE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de-DE" sz="16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therapy</a:t>
                </a:r>
                <a:endParaRPr lang="de-DE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" name="Textfeld 13">
                <a:extLst>
                  <a:ext uri="{FF2B5EF4-FFF2-40B4-BE49-F238E27FC236}">
                    <a16:creationId xmlns:a16="http://schemas.microsoft.com/office/drawing/2014/main" id="{2E02F935-D3C2-4EAB-80B8-364D52D20743}"/>
                  </a:ext>
                </a:extLst>
              </p:cNvPr>
              <p:cNvSpPr txBox="1"/>
              <p:nvPr/>
            </p:nvSpPr>
            <p:spPr>
              <a:xfrm>
                <a:off x="4566053" y="814049"/>
                <a:ext cx="1639927" cy="31944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p16+</a:t>
                </a:r>
              </a:p>
            </p:txBody>
          </p:sp>
          <p:sp>
            <p:nvSpPr>
              <p:cNvPr id="15" name="Textfeld 14">
                <a:extLst>
                  <a:ext uri="{FF2B5EF4-FFF2-40B4-BE49-F238E27FC236}">
                    <a16:creationId xmlns:a16="http://schemas.microsoft.com/office/drawing/2014/main" id="{3D94276D-7FBB-4E01-BF9F-26451AF2DF6E}"/>
                  </a:ext>
                </a:extLst>
              </p:cNvPr>
              <p:cNvSpPr txBox="1"/>
              <p:nvPr/>
            </p:nvSpPr>
            <p:spPr>
              <a:xfrm>
                <a:off x="1088511" y="796360"/>
                <a:ext cx="1639927" cy="31944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p16+</a:t>
                </a:r>
              </a:p>
            </p:txBody>
          </p:sp>
          <p:sp>
            <p:nvSpPr>
              <p:cNvPr id="16" name="Textfeld 15">
                <a:extLst>
                  <a:ext uri="{FF2B5EF4-FFF2-40B4-BE49-F238E27FC236}">
                    <a16:creationId xmlns:a16="http://schemas.microsoft.com/office/drawing/2014/main" id="{CB2B348C-DF5D-4C10-93CF-A2F60C8E16EE}"/>
                  </a:ext>
                </a:extLst>
              </p:cNvPr>
              <p:cNvSpPr txBox="1"/>
              <p:nvPr/>
            </p:nvSpPr>
            <p:spPr>
              <a:xfrm>
                <a:off x="1164300" y="3437134"/>
                <a:ext cx="2234613" cy="31944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40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JCC8 </a:t>
                </a:r>
                <a:r>
                  <a:rPr lang="de-DE" sz="1400" dirty="0" err="1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tage</a:t>
                </a:r>
                <a:r>
                  <a:rPr lang="de-DE" sz="140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I + II</a:t>
                </a:r>
              </a:p>
            </p:txBody>
          </p:sp>
          <p:sp>
            <p:nvSpPr>
              <p:cNvPr id="17" name="Textfeld 16">
                <a:extLst>
                  <a:ext uri="{FF2B5EF4-FFF2-40B4-BE49-F238E27FC236}">
                    <a16:creationId xmlns:a16="http://schemas.microsoft.com/office/drawing/2014/main" id="{665AD5ED-82AE-4345-84D9-1B5A85778432}"/>
                  </a:ext>
                </a:extLst>
              </p:cNvPr>
              <p:cNvSpPr txBox="1"/>
              <p:nvPr/>
            </p:nvSpPr>
            <p:spPr>
              <a:xfrm>
                <a:off x="4643368" y="3429694"/>
                <a:ext cx="1929182" cy="31944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40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JCC8 </a:t>
                </a:r>
                <a:r>
                  <a:rPr lang="de-DE" sz="1400" dirty="0" err="1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tage</a:t>
                </a:r>
                <a:r>
                  <a:rPr lang="de-DE" sz="140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I + II</a:t>
                </a:r>
              </a:p>
            </p:txBody>
          </p:sp>
        </p:grpSp>
        <p:grpSp>
          <p:nvGrpSpPr>
            <p:cNvPr id="6" name="Gruppieren 5">
              <a:extLst>
                <a:ext uri="{FF2B5EF4-FFF2-40B4-BE49-F238E27FC236}">
                  <a16:creationId xmlns:a16="http://schemas.microsoft.com/office/drawing/2014/main" id="{6984E8D1-45E1-4CA4-93C7-574BEF67B150}"/>
                </a:ext>
              </a:extLst>
            </p:cNvPr>
            <p:cNvGrpSpPr/>
            <p:nvPr/>
          </p:nvGrpSpPr>
          <p:grpSpPr>
            <a:xfrm>
              <a:off x="-42300" y="972462"/>
              <a:ext cx="7029705" cy="5070274"/>
              <a:chOff x="101393" y="972462"/>
              <a:chExt cx="7029705" cy="5070274"/>
            </a:xfrm>
          </p:grpSpPr>
          <p:graphicFrame>
            <p:nvGraphicFramePr>
              <p:cNvPr id="7" name="Objekt 6">
                <a:extLst>
                  <a:ext uri="{FF2B5EF4-FFF2-40B4-BE49-F238E27FC236}">
                    <a16:creationId xmlns:a16="http://schemas.microsoft.com/office/drawing/2014/main" id="{C1060BFB-6089-4530-B361-79B2226912F4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4023334042"/>
                  </p:ext>
                </p:extLst>
              </p:nvPr>
            </p:nvGraphicFramePr>
            <p:xfrm>
              <a:off x="152489" y="972462"/>
              <a:ext cx="3596462" cy="2505634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050" name="Prism 9" r:id="rId3" imgW="3841928" imgH="2675945" progId="Prism9.Document">
                      <p:embed/>
                    </p:oleObj>
                  </mc:Choice>
                  <mc:Fallback>
                    <p:oleObj name="Prism 9" r:id="rId3" imgW="3841928" imgH="2675945" progId="Prism9.Document">
                      <p:embed/>
                      <p:pic>
                        <p:nvPicPr>
                          <p:cNvPr id="4" name="Objekt 3">
                            <a:extLst>
                              <a:ext uri="{FF2B5EF4-FFF2-40B4-BE49-F238E27FC236}">
                                <a16:creationId xmlns:a16="http://schemas.microsoft.com/office/drawing/2014/main" id="{DE12A858-2CE8-4FF5-93B5-9016A37D0EF8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4"/>
                          <a:stretch>
                            <a:fillRect/>
                          </a:stretch>
                        </p:blipFill>
                        <p:spPr>
                          <a:xfrm>
                            <a:off x="152489" y="972462"/>
                            <a:ext cx="3596462" cy="2505634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8" name="Objekt 7">
                <a:extLst>
                  <a:ext uri="{FF2B5EF4-FFF2-40B4-BE49-F238E27FC236}">
                    <a16:creationId xmlns:a16="http://schemas.microsoft.com/office/drawing/2014/main" id="{4A0E47AD-C04F-4239-8AEC-CC1EC6BC5B5F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321722247"/>
                  </p:ext>
                </p:extLst>
              </p:nvPr>
            </p:nvGraphicFramePr>
            <p:xfrm>
              <a:off x="3466116" y="974484"/>
              <a:ext cx="3646420" cy="254044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051" name="Prism 9" r:id="rId5" imgW="3841928" imgH="2675945" progId="Prism9.Document">
                      <p:embed/>
                    </p:oleObj>
                  </mc:Choice>
                  <mc:Fallback>
                    <p:oleObj name="Prism 9" r:id="rId5" imgW="3841928" imgH="2675945" progId="Prism9.Document">
                      <p:embed/>
                      <p:pic>
                        <p:nvPicPr>
                          <p:cNvPr id="6" name="Objekt 5">
                            <a:extLst>
                              <a:ext uri="{FF2B5EF4-FFF2-40B4-BE49-F238E27FC236}">
                                <a16:creationId xmlns:a16="http://schemas.microsoft.com/office/drawing/2014/main" id="{FBF2A648-1CF4-481C-9503-5E15C3BC4FAE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6"/>
                          <a:stretch>
                            <a:fillRect/>
                          </a:stretch>
                        </p:blipFill>
                        <p:spPr>
                          <a:xfrm>
                            <a:off x="3466116" y="974484"/>
                            <a:ext cx="3646420" cy="254044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9" name="Objekt 8">
                <a:extLst>
                  <a:ext uri="{FF2B5EF4-FFF2-40B4-BE49-F238E27FC236}">
                    <a16:creationId xmlns:a16="http://schemas.microsoft.com/office/drawing/2014/main" id="{73E3D9D9-E917-4E89-B923-AF1CBC543A5B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1277064020"/>
                  </p:ext>
                </p:extLst>
              </p:nvPr>
            </p:nvGraphicFramePr>
            <p:xfrm>
              <a:off x="101393" y="3501503"/>
              <a:ext cx="3647558" cy="2541233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052" name="Prism 9" r:id="rId7" imgW="3841928" imgH="2675945" progId="Prism9.Document">
                      <p:embed/>
                    </p:oleObj>
                  </mc:Choice>
                  <mc:Fallback>
                    <p:oleObj name="Prism 9" r:id="rId7" imgW="3841928" imgH="2675945" progId="Prism9.Document">
                      <p:embed/>
                      <p:pic>
                        <p:nvPicPr>
                          <p:cNvPr id="7" name="Objekt 6">
                            <a:extLst>
                              <a:ext uri="{FF2B5EF4-FFF2-40B4-BE49-F238E27FC236}">
                                <a16:creationId xmlns:a16="http://schemas.microsoft.com/office/drawing/2014/main" id="{DF3B8C9D-1A22-47D1-AF5F-799A067DB45C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8"/>
                          <a:stretch>
                            <a:fillRect/>
                          </a:stretch>
                        </p:blipFill>
                        <p:spPr>
                          <a:xfrm>
                            <a:off x="101393" y="3501503"/>
                            <a:ext cx="3647558" cy="2541233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10" name="Objekt 9">
                <a:extLst>
                  <a:ext uri="{FF2B5EF4-FFF2-40B4-BE49-F238E27FC236}">
                    <a16:creationId xmlns:a16="http://schemas.microsoft.com/office/drawing/2014/main" id="{8EE4C932-E529-401D-8E32-3FBC285087E1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3678534173"/>
                  </p:ext>
                </p:extLst>
              </p:nvPr>
            </p:nvGraphicFramePr>
            <p:xfrm>
              <a:off x="3458538" y="3492355"/>
              <a:ext cx="3672560" cy="254044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053" name="Prism 9" r:id="rId9" imgW="3841928" imgH="2657577" progId="Prism9.Document">
                      <p:embed/>
                    </p:oleObj>
                  </mc:Choice>
                  <mc:Fallback>
                    <p:oleObj name="Prism 9" r:id="rId9" imgW="3841928" imgH="2657577" progId="Prism9.Document">
                      <p:embed/>
                      <p:pic>
                        <p:nvPicPr>
                          <p:cNvPr id="9" name="Objekt 8">
                            <a:extLst>
                              <a:ext uri="{FF2B5EF4-FFF2-40B4-BE49-F238E27FC236}">
                                <a16:creationId xmlns:a16="http://schemas.microsoft.com/office/drawing/2014/main" id="{365953C5-7112-494F-A196-F2C51F70889C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0"/>
                          <a:stretch>
                            <a:fillRect/>
                          </a:stretch>
                        </p:blipFill>
                        <p:spPr>
                          <a:xfrm>
                            <a:off x="3458538" y="3492355"/>
                            <a:ext cx="3672560" cy="254044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</p:grpSp>
      </p:grpSp>
      <p:sp>
        <p:nvSpPr>
          <p:cNvPr id="25" name="Textfeld 24">
            <a:extLst>
              <a:ext uri="{FF2B5EF4-FFF2-40B4-BE49-F238E27FC236}">
                <a16:creationId xmlns:a16="http://schemas.microsoft.com/office/drawing/2014/main" id="{25F1F0F5-846B-4F12-8A1C-A74E3A4DA07E}"/>
              </a:ext>
            </a:extLst>
          </p:cNvPr>
          <p:cNvSpPr txBox="1"/>
          <p:nvPr/>
        </p:nvSpPr>
        <p:spPr>
          <a:xfrm>
            <a:off x="478905" y="6455858"/>
            <a:ext cx="5638954" cy="86389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ts val="1000"/>
              </a:lnSpc>
              <a:spcBef>
                <a:spcPts val="1200"/>
              </a:spcBef>
            </a:pPr>
            <a:r>
              <a:rPr lang="en-US" sz="10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dditional f</a:t>
            </a:r>
            <a:r>
              <a:rPr lang="en-US" sz="10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gure 2: Gender specific overall survival according to therapy. </a:t>
            </a:r>
            <a:r>
              <a:rPr lang="en-US" sz="1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Gender-specific overall survival of patients treated with surgery +/- adjuvant therapy (</a:t>
            </a:r>
            <a:r>
              <a:rPr lang="en-US" sz="10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, C</a:t>
            </a:r>
            <a:r>
              <a:rPr lang="en-US" sz="1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or definitive </a:t>
            </a:r>
            <a:r>
              <a:rPr lang="en-US" sz="10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adiochemotherapy</a:t>
            </a:r>
            <a:r>
              <a:rPr lang="en-US" sz="1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RCT) (</a:t>
            </a:r>
            <a:r>
              <a:rPr lang="en-US" sz="10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, D</a:t>
            </a:r>
            <a:r>
              <a:rPr lang="en-US" sz="1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. </a:t>
            </a:r>
            <a:r>
              <a:rPr lang="en-US" sz="10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In the subgroup p16-positive (p16+) patients (defined </a:t>
            </a:r>
            <a:r>
              <a:rPr lang="en-US" sz="10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s either </a:t>
            </a:r>
            <a:r>
              <a:rPr lang="en-US" sz="1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16+/HPV+ or </a:t>
            </a:r>
            <a:r>
              <a:rPr lang="en-US" sz="10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16+/HPV-</a:t>
            </a:r>
            <a:r>
              <a:rPr lang="en-US" sz="1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; n = 247); </a:t>
            </a:r>
            <a:r>
              <a:rPr lang="en-US" sz="10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In the </a:t>
            </a:r>
            <a:r>
              <a:rPr lang="en-US" sz="10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bgroup </a:t>
            </a:r>
            <a:r>
              <a:rPr lang="en-US" sz="100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16</a:t>
            </a:r>
            <a:r>
              <a:rPr lang="en-US" sz="10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+ </a:t>
            </a:r>
            <a:r>
              <a:rPr lang="en-US" sz="1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atients (n = 109), </a:t>
            </a:r>
            <a:r>
              <a:rPr lang="en-US" sz="10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In the subgroup American Joint Committee of Cancer (AJCC)8th edition stage I+II (n = 369); </a:t>
            </a:r>
            <a:r>
              <a:rPr lang="en-US" sz="10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sz="1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In the subgroup AJCC8th I+II (n = 43)</a:t>
            </a:r>
            <a:endParaRPr lang="de-DE" sz="10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376578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39</Words>
  <Application>Microsoft Office PowerPoint</Application>
  <PresentationFormat>Breitbild</PresentationFormat>
  <Paragraphs>11</Paragraphs>
  <Slides>1</Slides>
  <Notes>0</Notes>
  <HiddenSlides>0</HiddenSlides>
  <MMClips>0</MMClips>
  <ScaleCrop>false</ScaleCrop>
  <HeadingPairs>
    <vt:vector size="8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Eingebettete OLE-Server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Palatino Linotype</vt:lpstr>
      <vt:lpstr>Office</vt:lpstr>
      <vt:lpstr>Prism 9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Charlotte Klasen</dc:creator>
  <cp:lastModifiedBy>Charlotte Klasen</cp:lastModifiedBy>
  <cp:revision>5</cp:revision>
  <dcterms:created xsi:type="dcterms:W3CDTF">2023-09-30T17:07:47Z</dcterms:created>
  <dcterms:modified xsi:type="dcterms:W3CDTF">2023-10-03T17:59:55Z</dcterms:modified>
</cp:coreProperties>
</file>